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0/03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26280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0/03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878497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Tsakmaki et al (2020) Diabetologia DOI 10.1007/s00125-020-05126-3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3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5762503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Organoid generation and application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924E360-8711-42EF-BE5B-0BB604B497C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5516" y="1117948"/>
            <a:ext cx="8712968" cy="42964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iabetologia logo.tif">
            <a:extLst>
              <a:ext uri="{FF2B5EF4-FFF2-40B4-BE49-F238E27FC236}">
                <a16:creationId xmlns:a16="http://schemas.microsoft.com/office/drawing/2014/main" id="{E05BA6D7-1649-4336-9AEB-1D53FC205DC8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5762503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88924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Tsakmaki et al (2020) Diabetologia DOI 10.1007/s00125-020-05126-3 </a:t>
            </a:r>
          </a:p>
          <a:p>
            <a:r>
              <a:rPr lang="en-GB" sz="1200" dirty="0"/>
              <a:t>(</a:t>
            </a:r>
            <a:r>
              <a:rPr lang="en-GB" sz="1200" b="1" dirty="0"/>
              <a:t>a</a:t>
            </a:r>
            <a:r>
              <a:rPr lang="en-GB" sz="1200" dirty="0"/>
              <a:t>) ©The Authors 2019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  <a:p>
            <a:r>
              <a:rPr lang="en-GB" sz="1200" dirty="0"/>
              <a:t>(</a:t>
            </a:r>
            <a:r>
              <a:rPr lang="en-GB" sz="1200" b="1" dirty="0"/>
              <a:t>b</a:t>
            </a:r>
            <a:r>
              <a:rPr lang="en-GB" sz="1200" dirty="0"/>
              <a:t>) ©2011 Elsevier, adapted with permission from Huh et al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2000" b="1" dirty="0"/>
              <a:t>Mini-me: modelling diabetes in 3D</a:t>
            </a:r>
            <a:endParaRPr lang="en-GB" sz="2000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E3DA16F-764D-4ADE-B2E7-8DAFA03DA7B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1379393"/>
            <a:ext cx="9144000" cy="40992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7892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4</TotalTime>
  <Words>109</Words>
  <Application>Microsoft Office PowerPoint</Application>
  <PresentationFormat>On-screen Show (4:3)</PresentationFormat>
  <Paragraphs>11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4</cp:revision>
  <dcterms:created xsi:type="dcterms:W3CDTF">2016-06-15T12:53:43Z</dcterms:created>
  <dcterms:modified xsi:type="dcterms:W3CDTF">2020-03-10T10:44:58Z</dcterms:modified>
</cp:coreProperties>
</file>